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428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34B47-6386-4A76-B167-F0D4365222E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0AB7D1-A79E-47F5-9F89-7C69250E7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352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285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782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4649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3678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1616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026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94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9622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4622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7734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9323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152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D7FF692-DA4E-DB7A-8677-FB6406071345}"/>
              </a:ext>
            </a:extLst>
          </p:cNvPr>
          <p:cNvSpPr txBox="1"/>
          <p:nvPr/>
        </p:nvSpPr>
        <p:spPr>
          <a:xfrm>
            <a:off x="409817" y="532085"/>
            <a:ext cx="4722622" cy="84330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15058E07-E91C-0107-67A8-C5C1F04A23F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7754005"/>
              </p:ext>
            </p:extLst>
          </p:nvPr>
        </p:nvGraphicFramePr>
        <p:xfrm>
          <a:off x="692993" y="984585"/>
          <a:ext cx="1638037" cy="191855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25307">
                  <a:extLst>
                    <a:ext uri="{9D8B030D-6E8A-4147-A177-3AD203B41FA5}">
                      <a16:colId xmlns:a16="http://schemas.microsoft.com/office/drawing/2014/main" val="175090857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954982664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06754770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15875362"/>
                    </a:ext>
                  </a:extLst>
                </a:gridCol>
              </a:tblGrid>
              <a:tr h="187839"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c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S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441552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al neutron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5599009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-thermal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8491504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t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103635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 ray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435850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7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13669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7621284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BDFA7B3-A049-CBC5-C513-F38ED6D92B90}"/>
              </a:ext>
            </a:extLst>
          </p:cNvPr>
          <p:cNvSpPr txBox="1"/>
          <p:nvPr/>
        </p:nvSpPr>
        <p:spPr>
          <a:xfrm rot="16200000">
            <a:off x="-38393" y="1670612"/>
            <a:ext cx="865609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NC-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75512077-0AE9-A7E8-0805-B024185FC5B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6853699"/>
              </p:ext>
            </p:extLst>
          </p:nvPr>
        </p:nvGraphicFramePr>
        <p:xfrm>
          <a:off x="2646457" y="984585"/>
          <a:ext cx="1638037" cy="191855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25307">
                  <a:extLst>
                    <a:ext uri="{9D8B030D-6E8A-4147-A177-3AD203B41FA5}">
                      <a16:colId xmlns:a16="http://schemas.microsoft.com/office/drawing/2014/main" val="175090857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954982664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06754770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15875362"/>
                    </a:ext>
                  </a:extLst>
                </a:gridCol>
              </a:tblGrid>
              <a:tr h="187839"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c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S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441552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al neutron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5599009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-thermal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8491504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t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103635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 ray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435850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.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13669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.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7621284"/>
                  </a:ext>
                </a:extLst>
              </a:tr>
            </a:tbl>
          </a:graphicData>
        </a:graphic>
      </p:graphicFrame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17AB5F00-7643-4E61-9FE1-280D5F154C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2545495"/>
              </p:ext>
            </p:extLst>
          </p:nvPr>
        </p:nvGraphicFramePr>
        <p:xfrm>
          <a:off x="4599077" y="984585"/>
          <a:ext cx="1638037" cy="191855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25307">
                  <a:extLst>
                    <a:ext uri="{9D8B030D-6E8A-4147-A177-3AD203B41FA5}">
                      <a16:colId xmlns:a16="http://schemas.microsoft.com/office/drawing/2014/main" val="175090857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954982664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06754770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15875362"/>
                    </a:ext>
                  </a:extLst>
                </a:gridCol>
              </a:tblGrid>
              <a:tr h="187839"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c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S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441552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al neutron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5599009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-thermal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8491504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t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103635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 ray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435850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7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5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13669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.8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7621284"/>
                  </a:ext>
                </a:extLst>
              </a:tr>
            </a:tbl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1166CA6-EF9C-7160-DBD3-653ACE1A7E4D}"/>
              </a:ext>
            </a:extLst>
          </p:cNvPr>
          <p:cNvSpPr txBox="1"/>
          <p:nvPr/>
        </p:nvSpPr>
        <p:spPr>
          <a:xfrm>
            <a:off x="1245606" y="690717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mi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8604753-8D53-94FC-D7B4-28C42164FA09}"/>
              </a:ext>
            </a:extLst>
          </p:cNvPr>
          <p:cNvSpPr txBox="1"/>
          <p:nvPr/>
        </p:nvSpPr>
        <p:spPr>
          <a:xfrm>
            <a:off x="3164751" y="69071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0mi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A2533AE-CF7C-64B2-5357-70DCAD2D903C}"/>
              </a:ext>
            </a:extLst>
          </p:cNvPr>
          <p:cNvSpPr txBox="1"/>
          <p:nvPr/>
        </p:nvSpPr>
        <p:spPr>
          <a:xfrm>
            <a:off x="5185024" y="690716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0mi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4090A7B6-08C6-4FDB-9FAB-E114BDF010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3839121"/>
              </p:ext>
            </p:extLst>
          </p:nvPr>
        </p:nvGraphicFramePr>
        <p:xfrm>
          <a:off x="692993" y="3464607"/>
          <a:ext cx="1643365" cy="191855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25307">
                  <a:extLst>
                    <a:ext uri="{9D8B030D-6E8A-4147-A177-3AD203B41FA5}">
                      <a16:colId xmlns:a16="http://schemas.microsoft.com/office/drawing/2014/main" val="1750908571"/>
                    </a:ext>
                  </a:extLst>
                </a:gridCol>
                <a:gridCol w="376238">
                  <a:extLst>
                    <a:ext uri="{9D8B030D-6E8A-4147-A177-3AD203B41FA5}">
                      <a16:colId xmlns:a16="http://schemas.microsoft.com/office/drawing/2014/main" val="3954982664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06754770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15875362"/>
                    </a:ext>
                  </a:extLst>
                </a:gridCol>
              </a:tblGrid>
              <a:tr h="187839"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c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S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441552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al neutron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5599009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-thermal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8491504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t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103635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 ray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435850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ron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4</a:t>
                      </a:r>
                      <a:endParaRPr lang="en-US" altLang="ja-JP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13669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.5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7621284"/>
                  </a:ext>
                </a:extLst>
              </a:tr>
            </a:tbl>
          </a:graphicData>
        </a:graphic>
      </p:graphicFrame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BD6B7D5-D703-100B-1C2B-B638E4D6DCEB}"/>
              </a:ext>
            </a:extLst>
          </p:cNvPr>
          <p:cNvSpPr txBox="1"/>
          <p:nvPr/>
        </p:nvSpPr>
        <p:spPr>
          <a:xfrm rot="16200000">
            <a:off x="-119955" y="4232196"/>
            <a:ext cx="1028734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HuCCT-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id="{36C33A47-35DD-4480-5906-ACFC8310AD6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2523581"/>
              </p:ext>
            </p:extLst>
          </p:nvPr>
        </p:nvGraphicFramePr>
        <p:xfrm>
          <a:off x="2646457" y="3464607"/>
          <a:ext cx="1638037" cy="191855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25307">
                  <a:extLst>
                    <a:ext uri="{9D8B030D-6E8A-4147-A177-3AD203B41FA5}">
                      <a16:colId xmlns:a16="http://schemas.microsoft.com/office/drawing/2014/main" val="175090857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954982664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06754770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15875362"/>
                    </a:ext>
                  </a:extLst>
                </a:gridCol>
              </a:tblGrid>
              <a:tr h="187839"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c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S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441552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al neutron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5599009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-thermal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8491504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t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103635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 ray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435850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13669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5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7621284"/>
                  </a:ext>
                </a:extLst>
              </a:tr>
            </a:tbl>
          </a:graphicData>
        </a:graphic>
      </p:graphicFrame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7042F22D-6F63-2EEC-E3E8-5D88165DEE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5283256"/>
              </p:ext>
            </p:extLst>
          </p:nvPr>
        </p:nvGraphicFramePr>
        <p:xfrm>
          <a:off x="4599077" y="3464607"/>
          <a:ext cx="1638037" cy="191855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25307">
                  <a:extLst>
                    <a:ext uri="{9D8B030D-6E8A-4147-A177-3AD203B41FA5}">
                      <a16:colId xmlns:a16="http://schemas.microsoft.com/office/drawing/2014/main" val="175090857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954982664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06754770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15875362"/>
                    </a:ext>
                  </a:extLst>
                </a:gridCol>
              </a:tblGrid>
              <a:tr h="187839"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c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S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441552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al neutron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5599009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-thermal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8491504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t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103635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 ray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435850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.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13669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4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6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7621284"/>
                  </a:ext>
                </a:extLst>
              </a:tr>
            </a:tbl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6E72A41-C3EA-7D36-6758-5D6401128996}"/>
              </a:ext>
            </a:extLst>
          </p:cNvPr>
          <p:cNvSpPr txBox="1"/>
          <p:nvPr/>
        </p:nvSpPr>
        <p:spPr>
          <a:xfrm>
            <a:off x="1245606" y="3170739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mi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14DFA67-A188-37E4-A3ED-E7DB19680370}"/>
              </a:ext>
            </a:extLst>
          </p:cNvPr>
          <p:cNvSpPr txBox="1"/>
          <p:nvPr/>
        </p:nvSpPr>
        <p:spPr>
          <a:xfrm>
            <a:off x="3164751" y="3170738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0mi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314030D-1680-8EF9-3054-F6AC606AE7BB}"/>
              </a:ext>
            </a:extLst>
          </p:cNvPr>
          <p:cNvSpPr txBox="1"/>
          <p:nvPr/>
        </p:nvSpPr>
        <p:spPr>
          <a:xfrm>
            <a:off x="5185024" y="3170738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0mi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" name="表 20">
            <a:extLst>
              <a:ext uri="{FF2B5EF4-FFF2-40B4-BE49-F238E27FC236}">
                <a16:creationId xmlns:a16="http://schemas.microsoft.com/office/drawing/2014/main" id="{606521DC-731B-1C90-E461-54A6F5B153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9985506"/>
              </p:ext>
            </p:extLst>
          </p:nvPr>
        </p:nvGraphicFramePr>
        <p:xfrm>
          <a:off x="692993" y="6688409"/>
          <a:ext cx="2235200" cy="1013460"/>
        </p:xfrm>
        <a:graphic>
          <a:graphicData uri="http://schemas.openxmlformats.org/drawingml/2006/table">
            <a:tbl>
              <a:tblPr/>
              <a:tblGrid>
                <a:gridCol w="406400">
                  <a:extLst>
                    <a:ext uri="{9D8B030D-6E8A-4147-A177-3AD203B41FA5}">
                      <a16:colId xmlns:a16="http://schemas.microsoft.com/office/drawing/2014/main" val="3288943290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3836039529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4240561970"/>
                    </a:ext>
                  </a:extLst>
                </a:gridCol>
              </a:tblGrid>
              <a:tr h="25146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hermal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Epi-thermal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4994354"/>
                  </a:ext>
                </a:extLst>
              </a:tr>
              <a:tr h="2514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0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.29E+1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.12E+1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5564577"/>
                  </a:ext>
                </a:extLst>
              </a:tr>
              <a:tr h="2514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0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97E+1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.65E+1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0181272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02E+1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90E+1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9888901"/>
                  </a:ext>
                </a:extLst>
              </a:tr>
            </a:tbl>
          </a:graphicData>
        </a:graphic>
      </p:graphicFrame>
      <p:graphicFrame>
        <p:nvGraphicFramePr>
          <p:cNvPr id="27" name="表 26">
            <a:extLst>
              <a:ext uri="{FF2B5EF4-FFF2-40B4-BE49-F238E27FC236}">
                <a16:creationId xmlns:a16="http://schemas.microsoft.com/office/drawing/2014/main" id="{92FD1D12-DBD9-922F-B50C-40D636AF10C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5178464"/>
              </p:ext>
            </p:extLst>
          </p:nvPr>
        </p:nvGraphicFramePr>
        <p:xfrm>
          <a:off x="4001914" y="6688409"/>
          <a:ext cx="2235200" cy="1295400"/>
        </p:xfrm>
        <a:graphic>
          <a:graphicData uri="http://schemas.openxmlformats.org/drawingml/2006/table">
            <a:tbl>
              <a:tblPr/>
              <a:tblGrid>
                <a:gridCol w="406400">
                  <a:extLst>
                    <a:ext uri="{9D8B030D-6E8A-4147-A177-3AD203B41FA5}">
                      <a16:colId xmlns:a16="http://schemas.microsoft.com/office/drawing/2014/main" val="2683754349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3372922394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97466927"/>
                    </a:ext>
                  </a:extLst>
                </a:gridCol>
              </a:tblGrid>
              <a:tr h="25908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hermal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Epi-thermal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4531969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30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.14E+1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7.68E+1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312668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0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.59E+1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.81E+1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94837760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0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39E+1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.59E+1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131630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m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6.96E+1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1.30E+1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4769842"/>
                  </a:ext>
                </a:extLst>
              </a:tr>
            </a:tbl>
          </a:graphicData>
        </a:graphic>
      </p:graphicFrame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7992418-E931-6ED4-36DB-FF58D34F6574}"/>
              </a:ext>
            </a:extLst>
          </p:cNvPr>
          <p:cNvSpPr txBox="1"/>
          <p:nvPr/>
        </p:nvSpPr>
        <p:spPr>
          <a:xfrm>
            <a:off x="207818" y="152400"/>
            <a:ext cx="40766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D2381D6-D0F5-42CF-22BF-C723385FC358}"/>
              </a:ext>
            </a:extLst>
          </p:cNvPr>
          <p:cNvSpPr txBox="1"/>
          <p:nvPr/>
        </p:nvSpPr>
        <p:spPr>
          <a:xfrm>
            <a:off x="1151598" y="6226744"/>
            <a:ext cx="13179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eutron Fluence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PANC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C9F0454-C366-9BCC-3595-3634B46C6E39}"/>
              </a:ext>
            </a:extLst>
          </p:cNvPr>
          <p:cNvSpPr txBox="1"/>
          <p:nvPr/>
        </p:nvSpPr>
        <p:spPr>
          <a:xfrm>
            <a:off x="4524682" y="6226743"/>
            <a:ext cx="13179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eutron Fluence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HuCCT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3733C2B-D3A8-6DC1-72CC-1022FC2C2849}"/>
              </a:ext>
            </a:extLst>
          </p:cNvPr>
          <p:cNvSpPr txBox="1"/>
          <p:nvPr/>
        </p:nvSpPr>
        <p:spPr>
          <a:xfrm>
            <a:off x="1541783" y="2900842"/>
            <a:ext cx="7892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unit: Gy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EE19F10-9005-96DA-102B-00A0F1AFB2E0}"/>
              </a:ext>
            </a:extLst>
          </p:cNvPr>
          <p:cNvSpPr txBox="1"/>
          <p:nvPr/>
        </p:nvSpPr>
        <p:spPr>
          <a:xfrm>
            <a:off x="3495246" y="2900842"/>
            <a:ext cx="7892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unit: Gy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1E034F0-C353-B92B-02E2-CC5519E07196}"/>
              </a:ext>
            </a:extLst>
          </p:cNvPr>
          <p:cNvSpPr txBox="1"/>
          <p:nvPr/>
        </p:nvSpPr>
        <p:spPr>
          <a:xfrm>
            <a:off x="5447022" y="2900842"/>
            <a:ext cx="7892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unit: Gy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A64C390-6B16-344B-E9F5-C0E597D66843}"/>
              </a:ext>
            </a:extLst>
          </p:cNvPr>
          <p:cNvSpPr txBox="1"/>
          <p:nvPr/>
        </p:nvSpPr>
        <p:spPr>
          <a:xfrm>
            <a:off x="1541783" y="5386622"/>
            <a:ext cx="7892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unit: Gy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AFCE860-461A-5E1E-5BB5-A1F3DB8DF8E3}"/>
              </a:ext>
            </a:extLst>
          </p:cNvPr>
          <p:cNvSpPr txBox="1"/>
          <p:nvPr/>
        </p:nvSpPr>
        <p:spPr>
          <a:xfrm>
            <a:off x="3495246" y="5386622"/>
            <a:ext cx="7892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unit: Gy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B0BB797-B82B-744A-B819-98038D723040}"/>
              </a:ext>
            </a:extLst>
          </p:cNvPr>
          <p:cNvSpPr txBox="1"/>
          <p:nvPr/>
        </p:nvSpPr>
        <p:spPr>
          <a:xfrm>
            <a:off x="5447022" y="5383164"/>
            <a:ext cx="7892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unit: Gy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F57F025-D147-E183-B557-2BCD76A1E591}"/>
              </a:ext>
            </a:extLst>
          </p:cNvPr>
          <p:cNvSpPr txBox="1"/>
          <p:nvPr/>
        </p:nvSpPr>
        <p:spPr>
          <a:xfrm>
            <a:off x="2009628" y="7701869"/>
            <a:ext cx="91991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unit: cm</a:t>
            </a:r>
            <a:r>
              <a:rPr kumimoji="1" lang="en-US" altLang="ja-JP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26FA29E-E741-DFB5-AF6F-B678A24AE47D}"/>
              </a:ext>
            </a:extLst>
          </p:cNvPr>
          <p:cNvSpPr txBox="1"/>
          <p:nvPr/>
        </p:nvSpPr>
        <p:spPr>
          <a:xfrm>
            <a:off x="5318510" y="7983809"/>
            <a:ext cx="91991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unit: cm</a:t>
            </a:r>
            <a:r>
              <a:rPr kumimoji="1" lang="en-US" altLang="ja-JP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F01F2B4B-CD59-4A1C-A454-D21133817E99}"/>
              </a:ext>
            </a:extLst>
          </p:cNvPr>
          <p:cNvSpPr/>
          <p:nvPr/>
        </p:nvSpPr>
        <p:spPr>
          <a:xfrm>
            <a:off x="118798" y="8366968"/>
            <a:ext cx="675289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Irradiation dose and neutron fluence in CA19-9–positive and –negative cell lines treated with fucose-BSH–mediated BNCT.</a:t>
            </a:r>
            <a:b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A) Absorbed dose (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 in PANC-1 (CA19-9–negative) and HuCCT-1 (CA19-9–positive) cells after BNCT using either BPA or fucose-BSH at three time points (10, 20, and 30 min). (B) Corresponding neutron fluence (cm⁻²) measured in each condition.</a:t>
            </a:r>
            <a:b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se data illustrate the variation in dose delivery and neutron exposure in different tumor marker–defined cellular contexts during BNCT.</a:t>
            </a:r>
            <a:endParaRPr lang="ja-JP" altLang="ja-JP" sz="1200" kern="10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7529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732</TotalTime>
  <Words>449</Words>
  <Application>Microsoft Office PowerPoint</Application>
  <PresentationFormat>A4 210 x 297 mm</PresentationFormat>
  <Paragraphs>24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游明朝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平 典之</dc:creator>
  <cp:lastModifiedBy>道上 宏之</cp:lastModifiedBy>
  <cp:revision>194</cp:revision>
  <dcterms:created xsi:type="dcterms:W3CDTF">2022-06-29T03:55:00Z</dcterms:created>
  <dcterms:modified xsi:type="dcterms:W3CDTF">2025-08-06T07:12:30Z</dcterms:modified>
</cp:coreProperties>
</file>